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645456-6DB0-41D7-AEC8-0D7DFFA2A4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67057-FE73-409A-8036-9C5DF3F09E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9CFE11-A292-4960-B511-02B49FC472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1FEB47-C5AD-44F4-82B0-4DD261EFF0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0F5C4D-2599-4E79-A5C4-BBC1C5F323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F44245-18D0-4A56-8351-98C954B4B3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AD8820-018F-48A5-A502-B0E4A9289C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74B707-DDD3-41CA-8EEF-C7845333B3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27EFA-7F42-4447-9E04-DBD65F79AA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6B1BFC-A3D8-427B-AA11-EF5643F6DE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BB8D9C-41BB-46CA-8C95-BA83CDF8EB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07981-FC7E-4AF0-BF65-1003CEFF91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6306AC-259B-4979-9330-0AC8028AF8E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2057400" y="658800"/>
            <a:ext cx="457200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upplemental Table S3  </a:t>
            </a:r>
            <a:br>
              <a:rPr sz="2200"/>
            </a:b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ummary of Cell Viability Assays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057400" y="2057400"/>
          <a:ext cx="4648320" cy="838080"/>
        </p:xfrm>
        <a:graphic>
          <a:graphicData uri="http://schemas.openxmlformats.org/drawingml/2006/table">
            <a:tbl>
              <a:tblPr/>
              <a:tblGrid>
                <a:gridCol w="1371600"/>
                <a:gridCol w="1676520"/>
                <a:gridCol w="1600200"/>
              </a:tblGrid>
              <a:tr h="2890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u00637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C50 for Caki-1 Cells (nM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C 50 for 786-O Cells (nM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32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 Hours Treatm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 Hours Treatm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8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2057400" y="3733920"/>
          <a:ext cx="4648320" cy="838080"/>
        </p:xfrm>
        <a:graphic>
          <a:graphicData uri="http://schemas.openxmlformats.org/drawingml/2006/table">
            <a:tbl>
              <a:tblPr/>
              <a:tblGrid>
                <a:gridCol w="1317600"/>
                <a:gridCol w="1676520"/>
                <a:gridCol w="1654200"/>
              </a:tblGrid>
              <a:tr h="2793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emsirolim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C20 for Caki-1 Cells (nM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C30 for 786-O Cells (nM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 Hours Treatm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936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 Hours Treatm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21T18:50:51Z</dcterms:created>
  <dc:creator>cshs</dc:creator>
  <dc:description/>
  <dc:language>en-US</dc:language>
  <cp:lastModifiedBy>Zhang, Hao</cp:lastModifiedBy>
  <dcterms:modified xsi:type="dcterms:W3CDTF">2012-12-22T22:55:46Z</dcterms:modified>
  <cp:revision>2</cp:revision>
  <dc:subject/>
  <dc:title>PowerPoint Presentation</dc:title>
</cp:coreProperties>
</file>